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8" r:id="rId11"/>
    <p:sldId id="265" r:id="rId12"/>
    <p:sldId id="266" r:id="rId13"/>
    <p:sldId id="267" r:id="rId14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071" autoAdjust="0"/>
  </p:normalViewPr>
  <p:slideViewPr>
    <p:cSldViewPr>
      <p:cViewPr>
        <p:scale>
          <a:sx n="80" d="100"/>
          <a:sy n="80" d="100"/>
        </p:scale>
        <p:origin x="-2784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printerSettings" Target="printerSettings/printerSettings1.bin"/><Relationship Id="rId16" Type="http://schemas.openxmlformats.org/officeDocument/2006/relationships/presProps" Target="presProps.xml"/><Relationship Id="rId17" Type="http://schemas.openxmlformats.org/officeDocument/2006/relationships/viewProps" Target="viewProps.xml"/><Relationship Id="rId18" Type="http://schemas.openxmlformats.org/officeDocument/2006/relationships/theme" Target="theme/theme1.xml"/><Relationship Id="rId1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5665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7912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3198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3132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2060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9197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7198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949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4832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3187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920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04664-3673-45A2-9D8C-55D92F5A713F}" type="datetimeFigureOut">
              <a:rPr lang="ko-KR" altLang="en-US" smtClean="0"/>
              <a:t>16. 2. 28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92ED9-3F8A-4442-A047-15AA66B73E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5309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eg"/><Relationship Id="rId4" Type="http://schemas.openxmlformats.org/officeDocument/2006/relationships/image" Target="../media/image42.jpeg"/><Relationship Id="rId5" Type="http://schemas.openxmlformats.org/officeDocument/2006/relationships/image" Target="../media/image43.jpeg"/><Relationship Id="rId6" Type="http://schemas.openxmlformats.org/officeDocument/2006/relationships/image" Target="../media/image44.jpeg"/><Relationship Id="rId7" Type="http://schemas.openxmlformats.org/officeDocument/2006/relationships/image" Target="../media/image45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0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eg"/><Relationship Id="rId4" Type="http://schemas.openxmlformats.org/officeDocument/2006/relationships/image" Target="../media/image48.jpeg"/><Relationship Id="rId5" Type="http://schemas.openxmlformats.org/officeDocument/2006/relationships/image" Target="../media/image49.jpeg"/><Relationship Id="rId6" Type="http://schemas.openxmlformats.org/officeDocument/2006/relationships/image" Target="../media/image50.jpeg"/><Relationship Id="rId7" Type="http://schemas.openxmlformats.org/officeDocument/2006/relationships/image" Target="../media/image51.jpeg"/><Relationship Id="rId8" Type="http://schemas.openxmlformats.org/officeDocument/2006/relationships/image" Target="../media/image52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6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jpeg"/><Relationship Id="rId4" Type="http://schemas.openxmlformats.org/officeDocument/2006/relationships/image" Target="../media/image55.jpeg"/><Relationship Id="rId5" Type="http://schemas.openxmlformats.org/officeDocument/2006/relationships/image" Target="../media/image56.jpeg"/><Relationship Id="rId6" Type="http://schemas.openxmlformats.org/officeDocument/2006/relationships/image" Target="../media/image57.jpeg"/><Relationship Id="rId7" Type="http://schemas.openxmlformats.org/officeDocument/2006/relationships/image" Target="../media/image58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3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jpeg"/><Relationship Id="rId4" Type="http://schemas.openxmlformats.org/officeDocument/2006/relationships/image" Target="../media/image61.jpeg"/><Relationship Id="rId5" Type="http://schemas.openxmlformats.org/officeDocument/2006/relationships/image" Target="../media/image62.jpeg"/><Relationship Id="rId6" Type="http://schemas.openxmlformats.org/officeDocument/2006/relationships/image" Target="../media/image63.jpeg"/><Relationship Id="rId7" Type="http://schemas.openxmlformats.org/officeDocument/2006/relationships/image" Target="../media/image64.jpeg"/><Relationship Id="rId8" Type="http://schemas.openxmlformats.org/officeDocument/2006/relationships/image" Target="../media/image65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9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g"/><Relationship Id="rId3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g"/><Relationship Id="rId3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jpg"/><Relationship Id="rId3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4" Type="http://schemas.openxmlformats.org/officeDocument/2006/relationships/image" Target="../media/image11.jpeg"/><Relationship Id="rId5" Type="http://schemas.openxmlformats.org/officeDocument/2006/relationships/image" Target="../media/image12.jpeg"/><Relationship Id="rId6" Type="http://schemas.openxmlformats.org/officeDocument/2006/relationships/image" Target="../media/image13.jpeg"/><Relationship Id="rId7" Type="http://schemas.openxmlformats.org/officeDocument/2006/relationships/image" Target="../media/image14.jpeg"/><Relationship Id="rId8" Type="http://schemas.openxmlformats.org/officeDocument/2006/relationships/image" Target="../media/image15.jpeg"/><Relationship Id="rId9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4" Type="http://schemas.openxmlformats.org/officeDocument/2006/relationships/image" Target="../media/image19.jpeg"/><Relationship Id="rId5" Type="http://schemas.openxmlformats.org/officeDocument/2006/relationships/image" Target="../media/image20.jpeg"/><Relationship Id="rId6" Type="http://schemas.openxmlformats.org/officeDocument/2006/relationships/image" Target="../media/image21.jpeg"/><Relationship Id="rId7" Type="http://schemas.openxmlformats.org/officeDocument/2006/relationships/image" Target="../media/image22.jpeg"/><Relationship Id="rId8" Type="http://schemas.openxmlformats.org/officeDocument/2006/relationships/image" Target="../media/image23.jpeg"/><Relationship Id="rId9" Type="http://schemas.openxmlformats.org/officeDocument/2006/relationships/image" Target="../media/image24.jpeg"/><Relationship Id="rId10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jpeg"/><Relationship Id="rId3" Type="http://schemas.openxmlformats.org/officeDocument/2006/relationships/image" Target="../media/image27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4" Type="http://schemas.openxmlformats.org/officeDocument/2006/relationships/image" Target="../media/image30.jpeg"/><Relationship Id="rId5" Type="http://schemas.openxmlformats.org/officeDocument/2006/relationships/image" Target="../media/image31.jpeg"/><Relationship Id="rId6" Type="http://schemas.openxmlformats.org/officeDocument/2006/relationships/image" Target="../media/image32.jpeg"/><Relationship Id="rId7" Type="http://schemas.openxmlformats.org/officeDocument/2006/relationships/image" Target="../media/image33.jpeg"/><Relationship Id="rId8" Type="http://schemas.openxmlformats.org/officeDocument/2006/relationships/image" Target="../media/image34.jpeg"/><Relationship Id="rId9" Type="http://schemas.openxmlformats.org/officeDocument/2006/relationships/image" Target="../media/image35.jpeg"/><Relationship Id="rId10" Type="http://schemas.openxmlformats.org/officeDocument/2006/relationships/image" Target="../media/image36.jpeg"/><Relationship Id="rId11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jpeg"/><Relationship Id="rId3" Type="http://schemas.openxmlformats.org/officeDocument/2006/relationships/image" Target="../media/image3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629416" y="1339591"/>
            <a:ext cx="2511552" cy="5588406"/>
            <a:chOff x="732111" y="227218"/>
            <a:chExt cx="2511552" cy="5588406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111" y="536488"/>
              <a:ext cx="2511552" cy="5279136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436629" y="227218"/>
              <a:ext cx="10390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i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h</a:t>
              </a:r>
              <a:r>
                <a:rPr lang="en-US" altLang="ko-KR" sz="1400" i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rp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related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707472" y="1331640"/>
            <a:ext cx="2529840" cy="5596357"/>
            <a:chOff x="3243663" y="219267"/>
            <a:chExt cx="2529840" cy="5596357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3663" y="536488"/>
              <a:ext cx="2529840" cy="5279136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006811" y="219267"/>
              <a:ext cx="10903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i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B-phoR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-7937" y="-300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8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80689" y="418173"/>
            <a:ext cx="4820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A) Scaled time-resolved continuous gene expression dat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0979349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548680" y="467544"/>
            <a:ext cx="2753153" cy="1800000"/>
            <a:chOff x="0" y="3923928"/>
            <a:chExt cx="2753153" cy="1800000"/>
          </a:xfrm>
        </p:grpSpPr>
        <p:pic>
          <p:nvPicPr>
            <p:cNvPr id="9" name="그림 8" descr="XOO2569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3923928"/>
              <a:ext cx="2753153" cy="1800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232073" y="3992111"/>
              <a:ext cx="12073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lgB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56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548680" y="2243561"/>
            <a:ext cx="2753153" cy="1800000"/>
            <a:chOff x="0" y="5868144"/>
            <a:chExt cx="2753153" cy="1800000"/>
          </a:xfrm>
        </p:grpSpPr>
        <p:pic>
          <p:nvPicPr>
            <p:cNvPr id="12" name="그림 11" descr="XOO2602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0" y="5868144"/>
              <a:ext cx="2753153" cy="18000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232073" y="5956518"/>
              <a:ext cx="11737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liG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602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548680" y="4067944"/>
            <a:ext cx="2753153" cy="1800000"/>
            <a:chOff x="0" y="7740352"/>
            <a:chExt cx="2753153" cy="1800000"/>
          </a:xfrm>
        </p:grpSpPr>
        <p:pic>
          <p:nvPicPr>
            <p:cNvPr id="15" name="그림 14" descr="XOO2618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0" y="7740352"/>
              <a:ext cx="2753153" cy="18000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232073" y="7827218"/>
              <a:ext cx="12073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lh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618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546689" y="5857001"/>
            <a:ext cx="2753153" cy="1800000"/>
            <a:chOff x="4104847" y="539552"/>
            <a:chExt cx="2753153" cy="1800000"/>
          </a:xfrm>
        </p:grpSpPr>
        <p:pic>
          <p:nvPicPr>
            <p:cNvPr id="18" name="그림 17" descr="XOO2609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104847" y="539552"/>
              <a:ext cx="2753153" cy="18000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4336529" y="622593"/>
              <a:ext cx="11641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li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60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3645024" y="467544"/>
            <a:ext cx="2753153" cy="1800000"/>
            <a:chOff x="4086597" y="2330134"/>
            <a:chExt cx="2753153" cy="1800000"/>
          </a:xfrm>
        </p:grpSpPr>
        <p:pic>
          <p:nvPicPr>
            <p:cNvPr id="21" name="그림 20" descr="XOO2850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086597" y="2330134"/>
              <a:ext cx="2753153" cy="180000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4317479" y="2411760"/>
              <a:ext cx="13356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heW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50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3645365" y="2243561"/>
            <a:ext cx="2753153" cy="1800000"/>
            <a:chOff x="4104847" y="3924128"/>
            <a:chExt cx="2753153" cy="1800000"/>
          </a:xfrm>
        </p:grpSpPr>
        <p:pic>
          <p:nvPicPr>
            <p:cNvPr id="24" name="그림 23" descr="XOO2836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104847" y="3924128"/>
              <a:ext cx="2753153" cy="180000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4336529" y="3987919"/>
              <a:ext cx="12923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he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3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980728" y="107504"/>
            <a:ext cx="21146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Flagella and chemotaxis</a:t>
            </a:r>
          </a:p>
        </p:txBody>
      </p:sp>
    </p:spTree>
    <p:extLst>
      <p:ext uri="{BB962C8B-B14F-4D97-AF65-F5344CB8AC3E}">
        <p14:creationId xmlns:p14="http://schemas.microsoft.com/office/powerpoint/2010/main" val="3784633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78873" y="909117"/>
            <a:ext cx="2753153" cy="1800000"/>
            <a:chOff x="4104847" y="5652120"/>
            <a:chExt cx="2753153" cy="1800000"/>
          </a:xfrm>
        </p:grpSpPr>
        <p:pic>
          <p:nvPicPr>
            <p:cNvPr id="3" name="그림 2" descr="XOO2614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04847" y="5652120"/>
              <a:ext cx="2753153" cy="1800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4340721" y="5716111"/>
              <a:ext cx="1491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GDEF 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61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470148" y="2698173"/>
            <a:ext cx="2753153" cy="1800000"/>
            <a:chOff x="4104847" y="7344000"/>
            <a:chExt cx="2753153" cy="1800000"/>
          </a:xfrm>
        </p:grpSpPr>
        <p:pic>
          <p:nvPicPr>
            <p:cNvPr id="6" name="그림 5" descr="XOO2615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04847" y="7344000"/>
              <a:ext cx="2753153" cy="18000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340721" y="7449636"/>
              <a:ext cx="1491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GDEF 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615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477342" y="4500192"/>
            <a:ext cx="2753153" cy="1800000"/>
            <a:chOff x="1" y="175320"/>
            <a:chExt cx="2753153" cy="1800000"/>
          </a:xfrm>
        </p:grpSpPr>
        <p:pic>
          <p:nvPicPr>
            <p:cNvPr id="9" name="그림 8" descr="XOO2787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" y="175320"/>
              <a:ext cx="2753153" cy="1800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231272" y="242195"/>
              <a:ext cx="1491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GDEF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787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3573017" y="550696"/>
            <a:ext cx="2753153" cy="1800000"/>
            <a:chOff x="1" y="2330134"/>
            <a:chExt cx="2753153" cy="1800000"/>
          </a:xfrm>
        </p:grpSpPr>
        <p:pic>
          <p:nvPicPr>
            <p:cNvPr id="13" name="그림 12" descr="XOO2813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" y="2330134"/>
              <a:ext cx="2753153" cy="18000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232073" y="2426985"/>
              <a:ext cx="1233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rpf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1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3573016" y="2339752"/>
            <a:ext cx="2754108" cy="1800000"/>
            <a:chOff x="0" y="3904878"/>
            <a:chExt cx="2754108" cy="1800000"/>
          </a:xfrm>
        </p:grpSpPr>
        <p:pic>
          <p:nvPicPr>
            <p:cNvPr id="16" name="그림 15" descr="Xoo2810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0" y="3904878"/>
              <a:ext cx="2754108" cy="180000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32073" y="3982586"/>
              <a:ext cx="12250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ruB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10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3573016" y="4141771"/>
            <a:ext cx="2753153" cy="1800000"/>
            <a:chOff x="0" y="5868144"/>
            <a:chExt cx="2753153" cy="1800000"/>
          </a:xfrm>
        </p:grpSpPr>
        <p:pic>
          <p:nvPicPr>
            <p:cNvPr id="19" name="그림 18" descr="XOO2811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0" y="5868144"/>
              <a:ext cx="2753153" cy="180000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232073" y="5956518"/>
              <a:ext cx="12250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ruK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11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3573016" y="5961021"/>
            <a:ext cx="2753153" cy="1800000"/>
            <a:chOff x="0" y="7524328"/>
            <a:chExt cx="2753153" cy="1800000"/>
          </a:xfrm>
        </p:grpSpPr>
        <p:pic>
          <p:nvPicPr>
            <p:cNvPr id="22" name="그림 21" descr="XOO2812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0" y="7524328"/>
              <a:ext cx="2753153" cy="1800000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232073" y="7588319"/>
              <a:ext cx="12250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ru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812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3720909" y="200181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PTS-</a:t>
            </a:r>
            <a:r>
              <a:rPr lang="en-US" altLang="ko-KR" sz="1400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fru</a:t>
            </a:r>
            <a:endParaRPr lang="en-US" altLang="ko-KR" sz="1400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20688" y="232356"/>
            <a:ext cx="24432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-</a:t>
            </a:r>
            <a:r>
              <a:rPr lang="en-US" altLang="ko-KR" sz="14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uanylate</a:t>
            </a:r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cyclase</a:t>
            </a:r>
          </a:p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GGDEF domain containing)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444842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그룹 19"/>
          <p:cNvGrpSpPr/>
          <p:nvPr/>
        </p:nvGrpSpPr>
        <p:grpSpPr>
          <a:xfrm>
            <a:off x="625221" y="808927"/>
            <a:ext cx="2753153" cy="1800000"/>
            <a:chOff x="4104847" y="467544"/>
            <a:chExt cx="2753153" cy="1800000"/>
          </a:xfrm>
        </p:grpSpPr>
        <p:pic>
          <p:nvPicPr>
            <p:cNvPr id="18" name="그림 17" descr="XOO3168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04847" y="467544"/>
              <a:ext cx="2753153" cy="18000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4342725" y="545252"/>
              <a:ext cx="1369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M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68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620688" y="2591410"/>
            <a:ext cx="2753153" cy="1800000"/>
            <a:chOff x="4104847" y="2339752"/>
            <a:chExt cx="2753153" cy="1800000"/>
          </a:xfrm>
        </p:grpSpPr>
        <p:pic>
          <p:nvPicPr>
            <p:cNvPr id="21" name="그림 20" descr="XOO3169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04847" y="2339752"/>
              <a:ext cx="2753153" cy="180000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4336529" y="2440335"/>
              <a:ext cx="13260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L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6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625221" y="4373893"/>
            <a:ext cx="2753153" cy="1800000"/>
            <a:chOff x="4104847" y="3923928"/>
            <a:chExt cx="2753153" cy="1800000"/>
          </a:xfrm>
        </p:grpSpPr>
        <p:pic>
          <p:nvPicPr>
            <p:cNvPr id="24" name="그림 23" descr="XOO3170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104847" y="3923928"/>
              <a:ext cx="2753153" cy="180000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4336529" y="4002777"/>
              <a:ext cx="1343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K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0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9" name="그룹 28"/>
          <p:cNvGrpSpPr/>
          <p:nvPr/>
        </p:nvGrpSpPr>
        <p:grpSpPr>
          <a:xfrm>
            <a:off x="620688" y="6156376"/>
            <a:ext cx="2753153" cy="1800000"/>
            <a:chOff x="4104847" y="5724128"/>
            <a:chExt cx="2753153" cy="1800000"/>
          </a:xfrm>
        </p:grpSpPr>
        <p:pic>
          <p:nvPicPr>
            <p:cNvPr id="27" name="그림 26" descr="XOO3171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104847" y="5724128"/>
              <a:ext cx="2753153" cy="180000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4336529" y="5815186"/>
              <a:ext cx="1317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J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1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3647225" y="808927"/>
            <a:ext cx="2753153" cy="1800000"/>
            <a:chOff x="4104847" y="7164288"/>
            <a:chExt cx="2753153" cy="1800000"/>
          </a:xfrm>
        </p:grpSpPr>
        <p:pic>
          <p:nvPicPr>
            <p:cNvPr id="30" name="그림 29" descr="XOO3172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104847" y="7164288"/>
              <a:ext cx="2753153" cy="1800000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4341521" y="7271712"/>
              <a:ext cx="12843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I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2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3" name="그룹 32"/>
          <p:cNvGrpSpPr/>
          <p:nvPr/>
        </p:nvGrpSpPr>
        <p:grpSpPr>
          <a:xfrm>
            <a:off x="3645024" y="2591410"/>
            <a:ext cx="2753153" cy="1800000"/>
            <a:chOff x="1" y="169987"/>
            <a:chExt cx="2753153" cy="1800000"/>
          </a:xfrm>
        </p:grpSpPr>
        <p:pic>
          <p:nvPicPr>
            <p:cNvPr id="34" name="그림 33" descr="XOO3173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" y="169987"/>
              <a:ext cx="2753153" cy="18000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236265" y="242195"/>
              <a:ext cx="1351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H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822995" y="438274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i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gum</a:t>
            </a:r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operon</a:t>
            </a:r>
          </a:p>
        </p:txBody>
      </p:sp>
    </p:spTree>
    <p:extLst>
      <p:ext uri="{BB962C8B-B14F-4D97-AF65-F5344CB8AC3E}">
        <p14:creationId xmlns:p14="http://schemas.microsoft.com/office/powerpoint/2010/main" val="31977139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622889" y="657674"/>
            <a:ext cx="2753153" cy="1800000"/>
            <a:chOff x="1" y="2051720"/>
            <a:chExt cx="2753153" cy="1800000"/>
          </a:xfrm>
        </p:grpSpPr>
        <p:pic>
          <p:nvPicPr>
            <p:cNvPr id="5" name="그림 4" descr="XOO3166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" y="2051720"/>
              <a:ext cx="2753153" cy="18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32073" y="2130569"/>
              <a:ext cx="1351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6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614164" y="2439395"/>
            <a:ext cx="2753153" cy="1800000"/>
            <a:chOff x="0" y="3924128"/>
            <a:chExt cx="2753153" cy="1800000"/>
          </a:xfrm>
        </p:grpSpPr>
        <p:pic>
          <p:nvPicPr>
            <p:cNvPr id="8" name="그림 7" descr="XOO3174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0" y="3924128"/>
              <a:ext cx="2753153" cy="18000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32073" y="4021827"/>
              <a:ext cx="13612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G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614165" y="4221116"/>
            <a:ext cx="2753153" cy="1800000"/>
            <a:chOff x="1" y="5796336"/>
            <a:chExt cx="2753153" cy="1800000"/>
          </a:xfrm>
        </p:grpSpPr>
        <p:pic>
          <p:nvPicPr>
            <p:cNvPr id="11" name="그림 10" descr="XOO3175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" y="5796336"/>
              <a:ext cx="2753153" cy="180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32073" y="5869652"/>
              <a:ext cx="13356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F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5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614164" y="6015012"/>
            <a:ext cx="2753153" cy="1800000"/>
            <a:chOff x="0" y="7668344"/>
            <a:chExt cx="2753153" cy="1800000"/>
          </a:xfrm>
        </p:grpSpPr>
        <p:pic>
          <p:nvPicPr>
            <p:cNvPr id="14" name="그림 13" descr="XOO3176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0" y="7668344"/>
              <a:ext cx="2753153" cy="18000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37406" y="7751385"/>
              <a:ext cx="1343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E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3717032" y="720726"/>
            <a:ext cx="2753153" cy="1800000"/>
            <a:chOff x="4104847" y="467544"/>
            <a:chExt cx="2753153" cy="1800000"/>
          </a:xfrm>
        </p:grpSpPr>
        <p:pic>
          <p:nvPicPr>
            <p:cNvPr id="17" name="그림 16" descr="XOO3177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104847" y="467544"/>
              <a:ext cx="2753153" cy="180000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4342363" y="546393"/>
              <a:ext cx="1351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D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7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2" name="그룹 21"/>
          <p:cNvGrpSpPr/>
          <p:nvPr/>
        </p:nvGrpSpPr>
        <p:grpSpPr>
          <a:xfrm>
            <a:off x="3717032" y="2502447"/>
            <a:ext cx="2753153" cy="1800000"/>
            <a:chOff x="4104847" y="2195736"/>
            <a:chExt cx="2753153" cy="1800000"/>
          </a:xfrm>
        </p:grpSpPr>
        <p:pic>
          <p:nvPicPr>
            <p:cNvPr id="20" name="그림 19" descr="XOO3178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104847" y="2195736"/>
              <a:ext cx="2753153" cy="1800000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4336529" y="2282602"/>
              <a:ext cx="1351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C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8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5" name="그룹 24"/>
          <p:cNvGrpSpPr/>
          <p:nvPr/>
        </p:nvGrpSpPr>
        <p:grpSpPr>
          <a:xfrm>
            <a:off x="3718936" y="4284168"/>
            <a:ext cx="2751249" cy="1800000"/>
            <a:chOff x="4106751" y="3851920"/>
            <a:chExt cx="2751249" cy="1800000"/>
          </a:xfrm>
        </p:grpSpPr>
        <p:pic>
          <p:nvPicPr>
            <p:cNvPr id="23" name="그림 22" descr="XOO3179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4106751" y="3851920"/>
              <a:ext cx="2751249" cy="180000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336529" y="3948311"/>
              <a:ext cx="1343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gumB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17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980728" y="251520"/>
            <a:ext cx="20826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i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gum</a:t>
            </a:r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operon (continued)</a:t>
            </a:r>
          </a:p>
        </p:txBody>
      </p:sp>
    </p:spTree>
    <p:extLst>
      <p:ext uri="{BB962C8B-B14F-4D97-AF65-F5344CB8AC3E}">
        <p14:creationId xmlns:p14="http://schemas.microsoft.com/office/powerpoint/2010/main" val="26289171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767434"/>
            <a:ext cx="2505456" cy="75773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40624" y="467544"/>
            <a:ext cx="10999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i="1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hoP-phoQ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001"/>
          <a:stretch/>
        </p:blipFill>
        <p:spPr>
          <a:xfrm>
            <a:off x="620688" y="783336"/>
            <a:ext cx="2529840" cy="153441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832155" y="480052"/>
            <a:ext cx="1685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ron-uptake related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1910279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1856" y="1008896"/>
            <a:ext cx="2505456" cy="298704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96957" y="235169"/>
            <a:ext cx="21146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lagella and chemotaxis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933056" y="251520"/>
            <a:ext cx="24432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-</a:t>
            </a:r>
            <a:r>
              <a:rPr lang="en-US" altLang="ko-KR" sz="14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uanylate</a:t>
            </a:r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cyclase</a:t>
            </a:r>
          </a:p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GGDEF domain containing)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504" y="543395"/>
            <a:ext cx="2505456" cy="6321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42605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667666"/>
            <a:ext cx="2505456" cy="247497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1008" y="649224"/>
            <a:ext cx="2511552" cy="784555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47943" y="335587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TS-</a:t>
            </a:r>
            <a:r>
              <a:rPr lang="en-US" altLang="ko-KR" sz="14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ru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189684" y="359889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i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um operon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068746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그룹 44"/>
          <p:cNvGrpSpPr/>
          <p:nvPr/>
        </p:nvGrpSpPr>
        <p:grpSpPr>
          <a:xfrm>
            <a:off x="341110" y="1024758"/>
            <a:ext cx="6229542" cy="7075634"/>
            <a:chOff x="548680" y="247328"/>
            <a:chExt cx="6229542" cy="7075634"/>
          </a:xfrm>
        </p:grpSpPr>
        <p:grpSp>
          <p:nvGrpSpPr>
            <p:cNvPr id="13" name="그룹 12"/>
            <p:cNvGrpSpPr/>
            <p:nvPr/>
          </p:nvGrpSpPr>
          <p:grpSpPr>
            <a:xfrm>
              <a:off x="548680" y="247328"/>
              <a:ext cx="2753260" cy="1800000"/>
              <a:chOff x="488221" y="799009"/>
              <a:chExt cx="2753260" cy="1800000"/>
            </a:xfrm>
          </p:grpSpPr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8221" y="799009"/>
                <a:ext cx="2753260" cy="1800000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725588" y="895200"/>
                <a:ext cx="12843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rpG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1379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14" name="그룹 13"/>
            <p:cNvGrpSpPr/>
            <p:nvPr/>
          </p:nvGrpSpPr>
          <p:grpSpPr>
            <a:xfrm>
              <a:off x="548680" y="2014761"/>
              <a:ext cx="2753260" cy="1800000"/>
              <a:chOff x="475481" y="3084215"/>
              <a:chExt cx="2753260" cy="1800000"/>
            </a:xfrm>
          </p:grpSpPr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5481" y="3084215"/>
                <a:ext cx="2753260" cy="1800000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711431" y="3146003"/>
                <a:ext cx="12666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rpX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1380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15" name="그룹 14"/>
            <p:cNvGrpSpPr/>
            <p:nvPr/>
          </p:nvGrpSpPr>
          <p:grpSpPr>
            <a:xfrm>
              <a:off x="550774" y="3763144"/>
              <a:ext cx="2753260" cy="1800000"/>
              <a:chOff x="475481" y="5263745"/>
              <a:chExt cx="2753260" cy="1800000"/>
            </a:xfrm>
          </p:grpSpPr>
          <p:pic>
            <p:nvPicPr>
              <p:cNvPr id="11" name="그림 1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5481" y="5263745"/>
                <a:ext cx="2753260" cy="1800000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711746" y="5350611"/>
                <a:ext cx="1374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i="1" dirty="0" err="1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paB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75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31" name="그룹 30"/>
            <p:cNvGrpSpPr/>
            <p:nvPr/>
          </p:nvGrpSpPr>
          <p:grpSpPr>
            <a:xfrm>
              <a:off x="555259" y="5522962"/>
              <a:ext cx="2754108" cy="1800000"/>
              <a:chOff x="475481" y="5580112"/>
              <a:chExt cx="2754108" cy="1800000"/>
            </a:xfrm>
          </p:grpSpPr>
          <p:pic>
            <p:nvPicPr>
              <p:cNvPr id="29" name="그림 28" descr="Xoo0076.jpg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475481" y="5580112"/>
                <a:ext cx="2754108" cy="1800000"/>
              </a:xfrm>
              <a:prstGeom prst="rect">
                <a:avLst/>
              </a:prstGeom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707261" y="5634578"/>
                <a:ext cx="1374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rpE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76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34" name="그룹 33"/>
            <p:cNvGrpSpPr/>
            <p:nvPr/>
          </p:nvGrpSpPr>
          <p:grpSpPr>
            <a:xfrm>
              <a:off x="4024114" y="247328"/>
              <a:ext cx="2754108" cy="1800000"/>
              <a:chOff x="0" y="7344000"/>
              <a:chExt cx="2754108" cy="1800000"/>
            </a:xfrm>
          </p:grpSpPr>
          <p:pic>
            <p:nvPicPr>
              <p:cNvPr id="32" name="그림 31" descr="Xoo0077.jpg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0" y="7344000"/>
                <a:ext cx="2754108" cy="1800000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236265" y="7430586"/>
                <a:ext cx="1374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rpD6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77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38" name="그룹 37"/>
            <p:cNvGrpSpPr/>
            <p:nvPr/>
          </p:nvGrpSpPr>
          <p:grpSpPr>
            <a:xfrm>
              <a:off x="4018167" y="2014761"/>
              <a:ext cx="2754108" cy="1800000"/>
              <a:chOff x="4103892" y="247328"/>
              <a:chExt cx="2754108" cy="1800000"/>
            </a:xfrm>
          </p:grpSpPr>
          <p:pic>
            <p:nvPicPr>
              <p:cNvPr id="36" name="그림 35" descr="Xoo0078.jpg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4103892" y="247328"/>
                <a:ext cx="2754108" cy="1800000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4340721" y="347911"/>
                <a:ext cx="13596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rpD5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78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41" name="그룹 40"/>
            <p:cNvGrpSpPr/>
            <p:nvPr/>
          </p:nvGrpSpPr>
          <p:grpSpPr>
            <a:xfrm>
              <a:off x="4010397" y="3763144"/>
              <a:ext cx="2754108" cy="1800000"/>
              <a:chOff x="4103892" y="2014761"/>
              <a:chExt cx="2754108" cy="1800000"/>
            </a:xfrm>
          </p:grpSpPr>
          <p:pic>
            <p:nvPicPr>
              <p:cNvPr id="39" name="그림 38" descr="Xoo0095.jpg"/>
              <p:cNvPicPr>
                <a:picLocks noChangeAspect="1"/>
              </p:cNvPicPr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4103892" y="2014761"/>
                <a:ext cx="2754108" cy="1800000"/>
              </a:xfrm>
              <a:prstGeom prst="rect">
                <a:avLst/>
              </a:prstGeom>
            </p:spPr>
          </p:pic>
          <p:sp>
            <p:nvSpPr>
              <p:cNvPr id="40" name="TextBox 39"/>
              <p:cNvSpPr txBox="1"/>
              <p:nvPr/>
            </p:nvSpPr>
            <p:spPr>
              <a:xfrm>
                <a:off x="4340721" y="2091328"/>
                <a:ext cx="12827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pa1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95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44" name="그룹 43"/>
            <p:cNvGrpSpPr/>
            <p:nvPr/>
          </p:nvGrpSpPr>
          <p:grpSpPr>
            <a:xfrm>
              <a:off x="4024114" y="5522962"/>
              <a:ext cx="2754108" cy="1800000"/>
              <a:chOff x="4103892" y="4139952"/>
              <a:chExt cx="2754108" cy="1800000"/>
            </a:xfrm>
          </p:grpSpPr>
          <p:pic>
            <p:nvPicPr>
              <p:cNvPr id="42" name="그림 41" descr="Xoo0096.jpg"/>
              <p:cNvPicPr>
                <a:picLocks noChangeAspect="1"/>
              </p:cNvPicPr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4103892" y="4139952"/>
                <a:ext cx="2754108" cy="1800000"/>
              </a:xfrm>
              <a:prstGeom prst="rect">
                <a:avLst/>
              </a:prstGeom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4336529" y="4217660"/>
                <a:ext cx="12827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pa2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 (</a:t>
                </a:r>
                <a:r>
                  <a:rPr lang="en-US" altLang="ko-KR" sz="1200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oo0096</a:t>
                </a:r>
                <a:r>
                  <a:rPr lang="en-US" altLang="ko-KR" sz="12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)</a:t>
                </a:r>
                <a:endParaRPr lang="ko-KR" altLang="en-US" sz="1200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</p:grpSp>
      <p:sp>
        <p:nvSpPr>
          <p:cNvPr id="27" name="TextBox 26"/>
          <p:cNvSpPr txBox="1"/>
          <p:nvPr/>
        </p:nvSpPr>
        <p:spPr>
          <a:xfrm>
            <a:off x="332656" y="692639"/>
            <a:ext cx="1069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i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hrp </a:t>
            </a:r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related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88640" y="107504"/>
            <a:ext cx="5157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 </a:t>
            </a:r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Unscaled time-resolved continuous gene expression dat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9289848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그룹 27"/>
          <p:cNvGrpSpPr/>
          <p:nvPr/>
        </p:nvGrpSpPr>
        <p:grpSpPr>
          <a:xfrm>
            <a:off x="627267" y="287346"/>
            <a:ext cx="2754108" cy="1800000"/>
            <a:chOff x="0" y="971600"/>
            <a:chExt cx="2754108" cy="1800000"/>
          </a:xfrm>
        </p:grpSpPr>
        <p:pic>
          <p:nvPicPr>
            <p:cNvPr id="26" name="그림 25" descr="Xoo3666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971600"/>
              <a:ext cx="2754108" cy="1800000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231190" y="1034283"/>
              <a:ext cx="1300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B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66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1" name="그룹 30"/>
          <p:cNvGrpSpPr/>
          <p:nvPr/>
        </p:nvGrpSpPr>
        <p:grpSpPr>
          <a:xfrm>
            <a:off x="627267" y="2033918"/>
            <a:ext cx="2754108" cy="1800000"/>
            <a:chOff x="0" y="2772000"/>
            <a:chExt cx="2754108" cy="1800000"/>
          </a:xfrm>
        </p:grpSpPr>
        <p:pic>
          <p:nvPicPr>
            <p:cNvPr id="29" name="그림 28" descr="Xoo3667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0" y="2772000"/>
              <a:ext cx="2754108" cy="180000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232073" y="2845316"/>
              <a:ext cx="13083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R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667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4" name="그룹 33"/>
          <p:cNvGrpSpPr/>
          <p:nvPr/>
        </p:nvGrpSpPr>
        <p:grpSpPr>
          <a:xfrm>
            <a:off x="623689" y="3816116"/>
            <a:ext cx="2754108" cy="1800000"/>
            <a:chOff x="0" y="4499992"/>
            <a:chExt cx="2754108" cy="1800000"/>
          </a:xfrm>
        </p:grpSpPr>
        <p:pic>
          <p:nvPicPr>
            <p:cNvPr id="32" name="그림 31" descr="Xoo2462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0" y="4499992"/>
              <a:ext cx="2754108" cy="18000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232073" y="4568175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stS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2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7" name="그룹 36"/>
          <p:cNvGrpSpPr/>
          <p:nvPr/>
        </p:nvGrpSpPr>
        <p:grpSpPr>
          <a:xfrm>
            <a:off x="627267" y="5598314"/>
            <a:ext cx="2754108" cy="1800000"/>
            <a:chOff x="1191" y="6300192"/>
            <a:chExt cx="2754108" cy="1800000"/>
          </a:xfrm>
        </p:grpSpPr>
        <p:pic>
          <p:nvPicPr>
            <p:cNvPr id="35" name="그림 34" descr="Xoo2463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191" y="6300192"/>
              <a:ext cx="2754108" cy="1800000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232073" y="6383233"/>
              <a:ext cx="12586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stC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40" name="그룹 39"/>
          <p:cNvGrpSpPr/>
          <p:nvPr/>
        </p:nvGrpSpPr>
        <p:grpSpPr>
          <a:xfrm>
            <a:off x="631459" y="7380512"/>
            <a:ext cx="2754108" cy="1800000"/>
            <a:chOff x="0" y="8100392"/>
            <a:chExt cx="2754108" cy="1800000"/>
          </a:xfrm>
        </p:grpSpPr>
        <p:pic>
          <p:nvPicPr>
            <p:cNvPr id="38" name="그림 37" descr="Xoo2464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0" y="8100392"/>
              <a:ext cx="2754108" cy="1800000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236265" y="8169716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st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43" name="그룹 42"/>
          <p:cNvGrpSpPr/>
          <p:nvPr/>
        </p:nvGrpSpPr>
        <p:grpSpPr>
          <a:xfrm>
            <a:off x="3789040" y="305726"/>
            <a:ext cx="2754108" cy="1800000"/>
            <a:chOff x="4103892" y="179512"/>
            <a:chExt cx="2754108" cy="1800000"/>
          </a:xfrm>
        </p:grpSpPr>
        <p:pic>
          <p:nvPicPr>
            <p:cNvPr id="41" name="그림 40" descr="Xoo2465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103892" y="179512"/>
              <a:ext cx="2754108" cy="1800000"/>
            </a:xfrm>
            <a:prstGeom prst="rect">
              <a:avLst/>
            </a:prstGeom>
          </p:spPr>
        </p:pic>
        <p:sp>
          <p:nvSpPr>
            <p:cNvPr id="42" name="TextBox 41"/>
            <p:cNvSpPr txBox="1"/>
            <p:nvPr/>
          </p:nvSpPr>
          <p:spPr>
            <a:xfrm>
              <a:off x="4336529" y="275903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stB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5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46" name="그룹 45"/>
          <p:cNvGrpSpPr/>
          <p:nvPr/>
        </p:nvGrpSpPr>
        <p:grpSpPr>
          <a:xfrm>
            <a:off x="3792618" y="2087924"/>
            <a:ext cx="2754108" cy="1800000"/>
            <a:chOff x="4103892" y="2195736"/>
            <a:chExt cx="2754108" cy="1800000"/>
          </a:xfrm>
        </p:grpSpPr>
        <p:pic>
          <p:nvPicPr>
            <p:cNvPr id="44" name="그림 43" descr="Xoo2466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4103892" y="2195736"/>
              <a:ext cx="2754108" cy="1800000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4336529" y="2284110"/>
              <a:ext cx="13083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U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50" name="그룹 49"/>
          <p:cNvGrpSpPr/>
          <p:nvPr/>
        </p:nvGrpSpPr>
        <p:grpSpPr>
          <a:xfrm>
            <a:off x="3792618" y="3870122"/>
            <a:ext cx="2754108" cy="1800000"/>
            <a:chOff x="4103892" y="4067944"/>
            <a:chExt cx="2754108" cy="1800000"/>
          </a:xfrm>
        </p:grpSpPr>
        <p:pic>
          <p:nvPicPr>
            <p:cNvPr id="48" name="그림 47" descr="Xoo2460.jpg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4103892" y="4067944"/>
              <a:ext cx="2754108" cy="1800000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4340721" y="4122410"/>
              <a:ext cx="12843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oprO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0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54" name="그룹 53"/>
          <p:cNvGrpSpPr/>
          <p:nvPr/>
        </p:nvGrpSpPr>
        <p:grpSpPr>
          <a:xfrm>
            <a:off x="3792618" y="5652320"/>
            <a:ext cx="2754108" cy="1800000"/>
            <a:chOff x="4103892" y="5940152"/>
            <a:chExt cx="2754108" cy="1800000"/>
          </a:xfrm>
        </p:grpSpPr>
        <p:pic>
          <p:nvPicPr>
            <p:cNvPr id="52" name="그림 51" descr="Xoo2461.jpg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4103892" y="5940152"/>
              <a:ext cx="2754108" cy="1800000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4336529" y="5985093"/>
              <a:ext cx="1300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X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461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2060848" y="23751"/>
            <a:ext cx="10903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i="1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phoB-phoR</a:t>
            </a:r>
            <a:endParaRPr lang="en-US" altLang="ko-KR" sz="1400" i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8946239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621934" y="341730"/>
            <a:ext cx="2754108" cy="1800000"/>
            <a:chOff x="0" y="157411"/>
            <a:chExt cx="2754108" cy="1800000"/>
          </a:xfrm>
        </p:grpSpPr>
        <p:pic>
          <p:nvPicPr>
            <p:cNvPr id="12" name="그림 11" descr="Xoo0423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157411"/>
              <a:ext cx="2754108" cy="18000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241598" y="242195"/>
              <a:ext cx="1300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P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042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620688" y="2123928"/>
            <a:ext cx="2754108" cy="1800000"/>
            <a:chOff x="0" y="2330911"/>
            <a:chExt cx="2754108" cy="1800000"/>
          </a:xfrm>
        </p:grpSpPr>
        <p:pic>
          <p:nvPicPr>
            <p:cNvPr id="17" name="그림 16" descr="Xoo0424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0" y="2330911"/>
              <a:ext cx="2754108" cy="180000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246931" y="2422793"/>
              <a:ext cx="1300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hoP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042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1816109" y="23374"/>
            <a:ext cx="10999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i="1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phoP-phoQ</a:t>
            </a:r>
            <a:endParaRPr lang="en-US" altLang="ko-KR" sz="1400" i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5300942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470093" y="289498"/>
            <a:ext cx="2754108" cy="1800000"/>
            <a:chOff x="1191" y="175320"/>
            <a:chExt cx="2754108" cy="1800000"/>
          </a:xfrm>
        </p:grpSpPr>
        <p:pic>
          <p:nvPicPr>
            <p:cNvPr id="3" name="그림 2" descr="Xoo2114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191" y="175320"/>
              <a:ext cx="2754108" cy="1800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32073" y="242195"/>
              <a:ext cx="15392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onB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like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211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476672" y="2053124"/>
            <a:ext cx="2754108" cy="1800000"/>
            <a:chOff x="0" y="2330911"/>
            <a:chExt cx="2754108" cy="1800000"/>
          </a:xfrm>
        </p:grpSpPr>
        <p:pic>
          <p:nvPicPr>
            <p:cNvPr id="6" name="그림 5" descr="Xoo1666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0" y="2330911"/>
              <a:ext cx="2754108" cy="18000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37406" y="2403743"/>
              <a:ext cx="12153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olR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666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472480" y="3816750"/>
            <a:ext cx="2754108" cy="1800000"/>
            <a:chOff x="0" y="3996136"/>
            <a:chExt cx="2754108" cy="1800000"/>
          </a:xfrm>
        </p:grpSpPr>
        <p:pic>
          <p:nvPicPr>
            <p:cNvPr id="11" name="그림 10" descr="Xoo0901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0" y="3996136"/>
              <a:ext cx="2754108" cy="180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36265" y="4084310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ec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0901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477627" y="5580376"/>
            <a:ext cx="2753153" cy="1800000"/>
            <a:chOff x="1" y="5724328"/>
            <a:chExt cx="2753153" cy="1800000"/>
          </a:xfrm>
        </p:grpSpPr>
        <p:pic>
          <p:nvPicPr>
            <p:cNvPr id="14" name="그림 13" descr="XOO1260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" y="5724328"/>
              <a:ext cx="2753153" cy="18000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32073" y="5793452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ec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260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468902" y="7344000"/>
            <a:ext cx="2753153" cy="1800000"/>
            <a:chOff x="0" y="7020272"/>
            <a:chExt cx="2753153" cy="1800000"/>
          </a:xfrm>
        </p:grpSpPr>
        <p:pic>
          <p:nvPicPr>
            <p:cNvPr id="17" name="그림 16" descr="XOO1359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0" y="7020272"/>
              <a:ext cx="2753153" cy="180000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232073" y="7108646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ec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35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2" name="그룹 21"/>
          <p:cNvGrpSpPr/>
          <p:nvPr/>
        </p:nvGrpSpPr>
        <p:grpSpPr>
          <a:xfrm>
            <a:off x="3863994" y="289498"/>
            <a:ext cx="2754108" cy="1800000"/>
            <a:chOff x="4103892" y="395536"/>
            <a:chExt cx="2754108" cy="1800000"/>
          </a:xfrm>
        </p:grpSpPr>
        <p:pic>
          <p:nvPicPr>
            <p:cNvPr id="20" name="그림 19" descr="XOO3793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103892" y="395536"/>
              <a:ext cx="2754108" cy="1800000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4340721" y="487735"/>
              <a:ext cx="12073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ir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3793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5" name="그룹 24"/>
          <p:cNvGrpSpPr/>
          <p:nvPr/>
        </p:nvGrpSpPr>
        <p:grpSpPr>
          <a:xfrm>
            <a:off x="3868186" y="2053124"/>
            <a:ext cx="2753153" cy="1800000"/>
            <a:chOff x="4104847" y="2267744"/>
            <a:chExt cx="2753153" cy="1800000"/>
          </a:xfrm>
        </p:grpSpPr>
        <p:pic>
          <p:nvPicPr>
            <p:cNvPr id="23" name="그림 22" descr="XOO4431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4104847" y="2267744"/>
              <a:ext cx="2753153" cy="180000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336529" y="2356118"/>
              <a:ext cx="12073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irA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4431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3863994" y="3816750"/>
            <a:ext cx="2753153" cy="1800000"/>
            <a:chOff x="4104847" y="3923928"/>
            <a:chExt cx="2753153" cy="1800000"/>
          </a:xfrm>
        </p:grpSpPr>
        <p:pic>
          <p:nvPicPr>
            <p:cNvPr id="26" name="그림 25" descr="XOO0394.jpg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4104847" y="3923928"/>
              <a:ext cx="2753153" cy="1800000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4338425" y="3998585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iro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039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1" name="그룹 30"/>
          <p:cNvGrpSpPr/>
          <p:nvPr/>
        </p:nvGrpSpPr>
        <p:grpSpPr>
          <a:xfrm>
            <a:off x="3868186" y="5580376"/>
            <a:ext cx="2753153" cy="1800000"/>
            <a:chOff x="4104847" y="5652120"/>
            <a:chExt cx="2753153" cy="1800000"/>
          </a:xfrm>
        </p:grpSpPr>
        <p:pic>
          <p:nvPicPr>
            <p:cNvPr id="29" name="그림 28" descr="XOO1784.jpg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4104847" y="5652120"/>
              <a:ext cx="2753153" cy="180000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336529" y="5740494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iro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78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34" name="그룹 33"/>
          <p:cNvGrpSpPr/>
          <p:nvPr/>
        </p:nvGrpSpPr>
        <p:grpSpPr>
          <a:xfrm>
            <a:off x="3868186" y="7344000"/>
            <a:ext cx="2753153" cy="1800000"/>
            <a:chOff x="4104847" y="7344000"/>
            <a:chExt cx="2753153" cy="1800000"/>
          </a:xfrm>
        </p:grpSpPr>
        <p:pic>
          <p:nvPicPr>
            <p:cNvPr id="32" name="그림 31" descr="XOO1099.jpg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4104847" y="7344000"/>
              <a:ext cx="2753153" cy="18000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4336529" y="7449636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iroN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099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1137449" y="8007"/>
            <a:ext cx="1675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Iron uptake related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2299421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620688" y="611560"/>
            <a:ext cx="2753153" cy="1800000"/>
            <a:chOff x="1" y="157411"/>
            <a:chExt cx="2753153" cy="1800000"/>
          </a:xfrm>
        </p:grpSpPr>
        <p:pic>
          <p:nvPicPr>
            <p:cNvPr id="2" name="그림 1" descr="XOO1994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" y="157411"/>
              <a:ext cx="2753153" cy="180000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232073" y="242195"/>
              <a:ext cx="11224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rf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1994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616496" y="2400617"/>
            <a:ext cx="2753153" cy="1800000"/>
            <a:chOff x="1" y="2330134"/>
            <a:chExt cx="2753153" cy="1800000"/>
          </a:xfrm>
        </p:grpSpPr>
        <p:pic>
          <p:nvPicPr>
            <p:cNvPr id="5" name="그림 4" descr="XOO4149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" y="2330134"/>
              <a:ext cx="2753153" cy="18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36265" y="2403743"/>
              <a:ext cx="11224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err="1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fr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 (</a:t>
              </a:r>
              <a:r>
                <a:rPr lang="en-US" altLang="ko-KR" sz="1200" i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Xoo4149</a:t>
              </a:r>
              <a:r>
                <a:rPr lang="en-US" altLang="ko-KR" sz="12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  <a:endParaRPr lang="ko-KR" alt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826587" y="179512"/>
            <a:ext cx="2619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Iron uptake related (continued)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5947357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</TotalTime>
  <Words>322</Words>
  <Application>Microsoft Macintosh PowerPoint</Application>
  <PresentationFormat>On-screen Show (4:3)</PresentationFormat>
  <Paragraphs>80</Paragraphs>
  <Slides>1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승환</dc:creator>
  <cp:lastModifiedBy>김승환 .</cp:lastModifiedBy>
  <cp:revision>13</cp:revision>
  <dcterms:created xsi:type="dcterms:W3CDTF">2014-09-11T10:33:07Z</dcterms:created>
  <dcterms:modified xsi:type="dcterms:W3CDTF">2016-02-27T20:50:33Z</dcterms:modified>
</cp:coreProperties>
</file>